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303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19" userDrawn="1">
          <p15:clr>
            <a:srgbClr val="A4A3A4"/>
          </p15:clr>
        </p15:guide>
        <p15:guide id="2" pos="221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h" initials="k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77" autoAdjust="0"/>
    <p:restoredTop sz="94660"/>
  </p:normalViewPr>
  <p:slideViewPr>
    <p:cSldViewPr snapToGrid="0" showGuides="1">
      <p:cViewPr>
        <p:scale>
          <a:sx n="125" d="100"/>
          <a:sy n="125" d="100"/>
        </p:scale>
        <p:origin x="-60" y="1794"/>
      </p:cViewPr>
      <p:guideLst>
        <p:guide orient="horz" pos="3119"/>
        <p:guide pos="221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commentAuthors" Target="commentAuthors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 hasCustomPrompt="1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30200" y="254635"/>
            <a:ext cx="6369685" cy="9651365"/>
          </a:xfrm>
          <a:prstGeom prst="rect">
            <a:avLst/>
          </a:prstGeom>
        </p:spPr>
        <p:txBody>
          <a:bodyPr wrap="square">
            <a:noAutofit/>
          </a:bodyPr>
          <a:lstStyle/>
          <a:p>
            <a:pPr marL="0" algn="l" hangingPunct="0">
              <a:lnSpc>
                <a:spcPts val="800"/>
              </a:lnSpc>
            </a:pPr>
            <a:r>
              <a:rPr lang="en-US" altLang="zh-CN" sz="700" b="1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EXON1</a:t>
            </a:r>
            <a:endParaRPr lang="en-US" altLang="zh-CN" sz="700" i="1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C_Os02g01590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 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ATGGAGACCCGGGACGACGTCGCCGACGCCTCGGCGCTTCCCTACTCCTACTCGCCGCTCCCCGCCGGGGACGCCGCCTCCGCCGACCTCGCCGCCGCCC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H86(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VIN2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)   ATGGAGACCCGGGACGACGTCGCCGACGCCTCGGCGCTTCCCTACTCCTACTCGCCGCTCCCCGCCGGGGACGCCGCCTCCGCCGACCTCGCCGCCGCCC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_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02g01590 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GCCGTTCCCGGAGGCGCCCGCTCTGCGTCGCCCTGTTCCTCGCCTCCGCCGCGGTGATCCTCGCCGTGGCGGTCCTCTCCGGCGTCAGGCTCGCCGGGCG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H86(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VIN2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)   GCCGTTCCCGGAGGCGCCCGCTCTGCGTCGCCCTGTTCCTCGCCTCCGCCGCGGTGATCCTCGCCGTGGCGGTCCTCTCCGGCGTCAGGCTCGCCGGGCG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C_Os02g01590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 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CCCGCGACGACGACGATGGTCGTCCCGGGGGTGGTGGAGATGGAGATGGCGAGCAGGGGGCCGGAGTCCGGCGTGTCGGAGAAGACGTCGGGGGCGGAG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H86(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VIN2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)   CCCCGCGACGACGACGATGGTCGTCCCGGGGGTGGTGGAGATGGAGATGGCGAGCAGGGGGCCGGAGTCCGGCGTGTCGGAGAAGACGTCGGGGGCGGAG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_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02g01590 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GAGATGGTGAGGCTGATGGGCGGCGCGGCGGGTGGGGAGGCGTTCCCGTGGAGCAACGCGATGCTGCAATGGCAGCGCACCGGATTCCATTTCCAGCCCG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H86(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VIN2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)   GAGATGGTGAGGCTGATGGGCGGCGCGGCGGGTGGGGAGGCGTTCCCGTGGAGCAACGCGATGCTGCAATGGCAGCGCACCGGATTCCATTTCCAGCCCG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_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02g01590 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AGAGGAACTGGAT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GAACGATCCCAACG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H86(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VIN2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)   AGAGGAACTGGATGAACGATCCCAACG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b="1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EXON2</a:t>
            </a:r>
            <a:endParaRPr lang="en-US" altLang="zh-CN" sz="700" i="1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_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02g01590 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GTCCGGTGTACTACAAGGGTT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GGTACCACCTGTTCTACCAGTACAACCCGGATGGGGCGGTGTGGGGCAACAAGATCGCGTGGGGGCACGCGGTGTC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G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H86(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VIN2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)   GTCCGGTGTACTACAAGGGTTGGTACCACCTGTTCTACCAGTACAACCCGGATGGGGCGGTGTGGGGCAACAAGATCGCGTGGGGGCACGCGGTGTCCCG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_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02g01590 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GACCTCGTCCACTGGCGCCACCTCCCCCTCGCCATGGTTCCCGACCAGTGGTACGACGTCAACGGCGTCTGGACCGGCTCCGCCACCACCCTCCCCG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AC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H86(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VIN2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)   CGACCTCGTCCACTGGCGCCACCTCCCCCTCGCCATGGTTCCCGACCAGTGGTACGACGTCAACGGCGTCTGGACCGGCTCCGCCACCACCCTCCCCGAC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_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02g01590 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GGCCGCCTCGCCATGCTCTACACCGGCTCCACCAACGCCTCCGTCCAGGTCCAGTGCCTCGCCGTCCCCTCCGACCCCGACGACCCCCTCCTCACCAA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T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H86(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VIN2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)   GGCCGCCTCGCCATGCTCTACACCGGCTCCACCAACGCCTCCGTCCAGGTCCAGTGCCTCGCCGTCCCCTCCGACCCCGACGACCCCCTCCTCACCAACT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_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02g01590 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GGACCAAGTACCACGCCAACCCCGTCCTCTACCCTCCCCGCACCATCGGCGACCGCGACTTCCGCGACCCCACCACCGCCTGGCGCGACCCCTCCGA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GG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H86(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VIN2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)   GGACCAAGTACCACGCCAACCCCGTCCTCTACCCTCCCCGCACCATCGGCGACCGCGACTTCCGCGACCCCACCACCGCCTGGCGCGACCCCTCCGACGG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_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02g01590 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GACTGGCGGATCGTCATCGGCTCCAAGGACGAGCACCACGCCGGCATCGCCGTCGTCTACCGCACCGCCGACTTCGTCACCTACGACCTCCTCCCGG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GC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H86(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VIN2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)   CGACTGGCGGATCGTCATCGGCTCCAAGGACGAGCACCACGCCGGCATCGCCGTCGTCTACCGCACCGCCGACTTCGTCACCTACGACCTCCTCCCGGGC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_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02g01590 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TCCTCCACCGCGTCGAGGCCACGGGGATGTGGGAGTGCATCGACTTCTACCCGGTGGCCGGCGGCGAGGGGGTGGACATGACGGAGGCGATGTACG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GA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H86(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VIN2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)   CTCCTCCACCGCGTCGAGGCCACGGGGATGTGGGAGTGCATCGACTTCTACCCGGTGGCCGGCGGCGAGGGGGTGGACATGACGGAGGCGATGTACGCGA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_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02g01590 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GGAACAAGGGGGTGGTGCACGTGATGAAGGCGAGCATGGACGACGATCGCCATGACTACTACGCGCTGGGGAGGTACGACCCGGCGAGGAACGCGTGG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AC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H86(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VIN2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)   GGAACAAGGGGGTGGTGCACGTGATGAAGGCGAGCATGGACGACGATCGCCATGACTACTACGCGCTGGGGAGGTACGACCCGGCGAGGAACGCGTGGAC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_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02g01590 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GCCGCTGGACGCCGCCGCCGACGTCGGCATCGGCCTCCGCTACGACTGGGGCAAGTTCTATGCCTCCAAGACCTTCTACGATCCGGCCAAGCGCCGC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GC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H86(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VIN2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)   GCCGCTGGACGCCGCCGCCGACGTCGGCATCGGCCTCCGCTACGACTGGGGCAAGTTCTATGCCTCCAAGACCTTCTACGATCCGGCCAAGCGCCGCCGC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_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02g01590 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GTCCTCTGGGGTTGGGTCGGCGAGACCGACTCCGAGCGCGCCGACGTCGCCAAGGGTTGGG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TTCCCTCCAG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H86(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VIN2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)   GTCCTCTGGGGTTGGGTCGGCGAGACCGACTCCGAGCGCGCCGACGTCGCCAAGGGTTGGGCTTCCCTCCAG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b="1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EXON3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_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02g01590 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TCGATTCCTCGGACGGTGGAGCTG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GACACCAAGACGGGGAGCAACCTGCTGCAATGGCCGGTGGAGGAGGTGGAGACGCTGCGCACCAACTCCACCGACT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H86(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VIN2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)   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TCGATTCCTCGGACGGTGGAG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TGGACACCAAGACGGGGAGCAACCTGCTGCAATGGCCGGTGGAGGAGGTGGAGACGCTGCGCACCAACTCCACCGACT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_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02g01590 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TCGGCGGCATCACCGTCGACTACG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CTCCGTCTTCCCGCTCAACCTCCACCGCGCCACGCAGCTCGACATCCTCGCCGAGTTCCAGCTCGACCCGCTCGC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H86(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VIN2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)   TCGGCGGCATCACCGTCGACTACGCCTCCGTCTTCCCGCTCAACCTCCACCGCGCCACGCAGCTCGACATCCTCGCCGAGTTCCAGCTCGACCCGCTCGC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_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02g01590 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GTCGACGCCGTCCTCGAGGCCGA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GTCGGCTACAACTGCAGCACCAGCGGCGGCGCGGCCGGCCGGGGCGCCCTGGGCCCCTTCGGGCTGCTGGTGCTC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H86(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VIN2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)   CGTCGACGCCGTCCTCGAGGCCGACGTCGGCTACAACTGCAGCACCAGCGGCGGCGCGGCCGGCCGGGGCGCCCTGGGCCCCTTCGGGCTGCTGGTGCTC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C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_Os02g01590 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G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CGACAAGCGCCACCGCGGGGAT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GGGGAGCAGACCGCCGTGTACTTCTACGTGGCCAAGGGGAGCGACGGCGGCGTCACGACGCACTTCTGCCAGGACG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H86(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VIN2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)   GCCGACAAGCGCCACCGCGGGGATGGGGAGCAGACCGCCGTGTACTTCTACGTGGCCAAGGGGAGCGACGGCGGCGTCACGACGCACTTCTGCCAGGACG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_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02g01590 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AG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TCGAGGTCGTCGCACGCCGACG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ACATCGTCAAGAGGGTCGTCGGCAACGTCGTCCCGGTGCTCGACGGCGAGACCTTCTCCCTCCGGGTGCTCGTCGA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H86(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VIN2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)   AGTCGAGGTCGTCGCACGCCGACGACATCGTCAAGAGGGTCGTCGGCAACGTCGTCCCGGTGCTCGACGGCGAGACCTTCTCCCTCCGGGTGCTCGTCGA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_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02g01590 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CA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TCCATCGTCGAGAGCTTCG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GCAGGGGGGGAGGTCCACGGCGACGTCGCGGGTGTACCCCACGGAGGCCATCTACGCCAACGCCGGCGTCTTCCTC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H86(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VIN2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)   CCACTCCATCGTCGAGAGCTTCGCGCAGGGGGGGAGGTCCACGGCGACGTCGCGGGTGTACCCCACGGAGGCCATCTACGCCAACGCCGGCGTCTTCCTC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OC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_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02g01590 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T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TCAACAACGCCACCAGCGCGCGCGTCACGGCCAAGAAGCTCGTCGTCCACGAGATGGACTCCTCCTACAACCAAGCCTACATGGCCTAG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H86(</a:t>
            </a:r>
            <a:r>
              <a:rPr lang="en-US" altLang="zh-CN" sz="700" i="1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VIN2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)   TTCAACAACGCCACCAGCGCGCGCGTCACGGCCAAGAAGCTCGTCGTCCACGAGATGGACTCCTCCTACAACCAAGCCTACATGGCCTAG</a:t>
            </a:r>
            <a:r>
              <a:rPr lang="en-US" altLang="zh-CN" sz="700" kern="100">
                <a:solidFill>
                  <a:srgbClr val="000000"/>
                </a:solidFill>
                <a:latin typeface="Courier New" panose="020703090202050204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 </a:t>
            </a: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endParaRPr lang="en-US" altLang="zh-CN" sz="700" kern="100">
              <a:solidFill>
                <a:srgbClr val="000000"/>
              </a:solidFill>
              <a:latin typeface="Courier New" panose="020703090202050204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 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marL="0" algn="l" hangingPunct="0">
              <a:lnSpc>
                <a:spcPts val="800"/>
              </a:lnSpc>
            </a:pPr>
            <a:r>
              <a: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 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402590" y="7319010"/>
            <a:ext cx="5867400" cy="41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auto">
              <a:lnSpc>
                <a:spcPct val="130000"/>
              </a:lnSpc>
            </a:pPr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1.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on sequence of the </a:t>
            </a:r>
            <a:r>
              <a:rPr lang="en-US" altLang="zh-CN" sz="800" b="1" i="1" dirty="0">
                <a:latin typeface="Times New Roman" panose="02020603050405020304" pitchFamily="18" charset="0"/>
                <a:cs typeface="Times New Roman" panose="02020603050405020304" pitchFamily="18" charset="0"/>
                <a:sym typeface="Times New Roman" panose="02020603050405020304"/>
              </a:rPr>
              <a:t>OsVIN2</a:t>
            </a:r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in MH86 material.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t is consistent with the </a:t>
            </a:r>
            <a:r>
              <a:rPr lang="en-US" altLang="zh-CN" sz="800" i="1" dirty="0">
                <a:latin typeface="Times New Roman" panose="02020603050405020304" pitchFamily="18" charset="0"/>
                <a:cs typeface="Times New Roman" panose="02020603050405020304" pitchFamily="18" charset="0"/>
                <a:sym typeface="Times New Roman" panose="02020603050405020304"/>
              </a:rPr>
              <a:t>LOC_Os02g01590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sequence, indicating that the vin2 gene expression cassette in the edited material is intact without genomic variations that significantly affect gene function.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891</Words>
  <Application>WPS 演示</Application>
  <PresentationFormat>A4 纸张(210x297 毫米)</PresentationFormat>
  <Paragraphs>75</Paragraphs>
  <Slides>1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1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4" baseType="lpstr">
      <vt:lpstr>Arial</vt:lpstr>
      <vt:lpstr>宋体</vt:lpstr>
      <vt:lpstr>Wingdings</vt:lpstr>
      <vt:lpstr>Courier New</vt:lpstr>
      <vt:lpstr>Times New Roman</vt:lpstr>
      <vt:lpstr>Calibri</vt:lpstr>
      <vt:lpstr>Times New Roman</vt:lpstr>
      <vt:lpstr>等线</vt:lpstr>
      <vt:lpstr>微软雅黑</vt:lpstr>
      <vt:lpstr>Arial Unicode MS</vt:lpstr>
      <vt:lpstr>等线 Light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sb</dc:creator>
  <cp:lastModifiedBy>朱义旺</cp:lastModifiedBy>
  <cp:revision>373</cp:revision>
  <dcterms:created xsi:type="dcterms:W3CDTF">2018-09-24T01:01:00Z</dcterms:created>
  <dcterms:modified xsi:type="dcterms:W3CDTF">2025-12-18T03:46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4034</vt:lpwstr>
  </property>
  <property fmtid="{D5CDD505-2E9C-101B-9397-08002B2CF9AE}" pid="3" name="ICV">
    <vt:lpwstr>61B4EB843F6F44DC99892200BB848769_12</vt:lpwstr>
  </property>
</Properties>
</file>